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98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77EFBC-E745-4386-B566-4316446DA25A}" type="datetimeFigureOut">
              <a:rPr kumimoji="1" lang="ja-JP" altLang="en-US" smtClean="0"/>
              <a:t>2015/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C3343B-9D81-43B1-862C-978A07D465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666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0C6BDC-07DC-4E7C-A020-3E70E37F076F}" type="slidenum">
              <a:rPr lang="ja-JP" altLang="en-US" smtClean="0">
                <a:solidFill>
                  <a:prstClr val="black"/>
                </a:solidFill>
              </a:rPr>
              <a:pPr/>
              <a:t>1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1003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A3393-CEA9-4EFE-BAE7-9D7081075D72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092207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74CE8-4165-4A96-9677-AB9A4FF5D92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98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33C54C-AEBE-40B6-A636-4763CF5D4D57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5929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9FA4C8-3833-4FC2-8134-EA2CB0602FA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0679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23A7F-590B-486B-BE0A-B50197B21AF4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2485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EF3A3-C7AA-4E6E-B9B1-00CD68F9C952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541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EAFBF-EE48-4FFB-BFCA-2EAC629AFC9E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7488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838D3-13AB-4A14-A228-00037C82775F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0657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4EFFC-E18D-4DFD-9AC0-0FCC03B78929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3481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A8594-684B-45B9-9A66-0C037DFF0A5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651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82295-B92E-4A29-B22D-849AF10344DB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80769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pattFill prst="ltHorz">
          <a:fgClr>
            <a:schemeClr val="bg1">
              <a:lumMod val="95000"/>
            </a:schemeClr>
          </a:fgClr>
          <a:bgClr>
            <a:schemeClr val="bg1"/>
          </a:bgClr>
        </a:patt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847AB-38BE-45F8-875F-CB13AD905AA3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/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54796-8A15-40F4-AD2F-A383D813798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4878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37056105"/>
              </p:ext>
            </p:extLst>
          </p:nvPr>
        </p:nvGraphicFramePr>
        <p:xfrm>
          <a:off x="179512" y="908720"/>
          <a:ext cx="8897239" cy="53794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4868"/>
                <a:gridCol w="2546968"/>
                <a:gridCol w="950010"/>
                <a:gridCol w="954992"/>
                <a:gridCol w="2520280"/>
                <a:gridCol w="1080121"/>
              </a:tblGrid>
              <a:tr h="596754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dirty="0" smtClean="0">
                          <a:solidFill>
                            <a:prstClr val="black"/>
                          </a:solidFill>
                        </a:rPr>
                        <a:t>Route 1</a:t>
                      </a:r>
                      <a:endParaRPr lang="ja-JP" altLang="en-US" dirty="0" smtClean="0">
                        <a:solidFill>
                          <a:prstClr val="black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ja-JP" dirty="0" smtClean="0">
                          <a:solidFill>
                            <a:prstClr val="black"/>
                          </a:solidFill>
                        </a:rPr>
                        <a:t>Route 2</a:t>
                      </a:r>
                      <a:endParaRPr lang="ja-JP" altLang="en-US" dirty="0">
                        <a:solidFill>
                          <a:prstClr val="black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96754">
                <a:tc rowSpan="5"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5 </a:t>
                      </a:r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hou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5">
                  <a:txBody>
                    <a:bodyPr/>
                    <a:lstStyle/>
                    <a:p>
                      <a:pPr algn="l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Lactate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Ringer’s 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solution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en-US" altLang="ja-JP" sz="1800" b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gnesium</a:t>
                      </a:r>
                      <a:r>
                        <a:rPr kumimoji="1" lang="en-US" altLang="ja-JP" sz="18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ulfate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en-US" altLang="ja-JP" sz="18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toclopramid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</a:tcPr>
                </a:tc>
                <a:tc rowSpan="5"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1000 ml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0 mEq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0 mg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 </a:t>
                      </a:r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h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aintenance solutio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500 ml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97003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30 mi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Normal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 saline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Palonosetron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Dexamethason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100 ml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0.75 mg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9.9 mg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67902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10 mi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Normal saline</a:t>
                      </a:r>
                    </a:p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Pemetrexed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100 ml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endParaRPr kumimoji="1" lang="ja-JP" altLang="en-US" baseline="30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9675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30mi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Salin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e solutio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r>
                        <a:rPr kumimoji="1" lang="ja-JP" altLang="en-US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l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40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 </a:t>
                      </a:r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h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Normal saline</a:t>
                      </a:r>
                      <a:endParaRPr kumimoji="1" lang="en-US" altLang="ja-JP" baseline="0" dirty="0" smtClean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Cisplati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50</a:t>
                      </a:r>
                      <a:r>
                        <a:rPr kumimoji="1" lang="ja-JP" altLang="en-US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l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84966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 </a:t>
                      </a:r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h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annitol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300 ml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r"/>
                      <a:endParaRPr kumimoji="1" lang="ja-JP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r"/>
                      <a:endParaRPr kumimoji="1" lang="ja-JP" altLang="en-US" dirty="0"/>
                    </a:p>
                  </a:txBody>
                  <a:tcPr anchor="ctr"/>
                </a:tc>
              </a:tr>
              <a:tr h="44783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5 </a:t>
                      </a:r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h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Lactate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 Ringer’s solution</a:t>
                      </a:r>
                    </a:p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agnesium sulfate</a:t>
                      </a:r>
                    </a:p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etoclopramid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 1000 ml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0 mEq</a:t>
                      </a:r>
                      <a:endParaRPr kumimoji="1" lang="en-US" altLang="ja-JP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0 mg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81321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2 </a:t>
                      </a:r>
                      <a:r>
                        <a:rPr kumimoji="1" lang="en-US" altLang="ja-JP" dirty="0" err="1" smtClean="0">
                          <a:solidFill>
                            <a:schemeClr val="tx1"/>
                          </a:solidFill>
                        </a:rPr>
                        <a:t>hr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Maintenance</a:t>
                      </a:r>
                      <a:r>
                        <a:rPr kumimoji="1" lang="en-US" altLang="ja-JP" baseline="0" dirty="0" smtClean="0">
                          <a:solidFill>
                            <a:schemeClr val="tx1"/>
                          </a:solidFill>
                        </a:rPr>
                        <a:t> solutio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 smtClean="0">
                          <a:solidFill>
                            <a:schemeClr val="tx1"/>
                          </a:solidFill>
                        </a:rPr>
                        <a:t>500 ml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r"/>
                      <a:endParaRPr kumimoji="1" lang="ja-JP" altLang="en-US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3" name="タイトル 2"/>
          <p:cNvSpPr>
            <a:spLocks noGrp="1"/>
          </p:cNvSpPr>
          <p:nvPr>
            <p:ph type="title"/>
          </p:nvPr>
        </p:nvSpPr>
        <p:spPr>
          <a:xfrm>
            <a:off x="395536" y="116632"/>
            <a:ext cx="8229600" cy="782960"/>
          </a:xfrm>
        </p:spPr>
        <p:txBody>
          <a:bodyPr>
            <a:normAutofit/>
          </a:bodyPr>
          <a:lstStyle/>
          <a:p>
            <a:r>
              <a:rPr lang="en-US" altLang="ja-JP" sz="3200" dirty="0"/>
              <a:t>The chemotherapy hydration protocol</a:t>
            </a:r>
            <a:endParaRPr kumimoji="1" lang="ja-JP" altLang="en-US" sz="3200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712049" y="6372036"/>
            <a:ext cx="635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Total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419872" y="6372036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3850 ml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572000" y="6372036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10 </a:t>
            </a:r>
            <a:r>
              <a:rPr lang="en-US" altLang="ja-JP" dirty="0" smtClean="0">
                <a:solidFill>
                  <a:prstClr val="black"/>
                </a:solidFill>
              </a:rPr>
              <a:t>hour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5729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1</Words>
  <Application>Microsoft Office PowerPoint</Application>
  <PresentationFormat>画面に合わせる (4:3)</PresentationFormat>
  <Paragraphs>4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The chemotherapy hydration protocol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chemotherapy hydration protocol</dc:title>
  <dc:creator>Satoshi Watanabe</dc:creator>
  <cp:lastModifiedBy>Satoshi Watanabe</cp:lastModifiedBy>
  <cp:revision>2</cp:revision>
  <dcterms:created xsi:type="dcterms:W3CDTF">2015-01-01T05:13:12Z</dcterms:created>
  <dcterms:modified xsi:type="dcterms:W3CDTF">2015-01-01T05:22:21Z</dcterms:modified>
</cp:coreProperties>
</file>